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216650" cy="8686800"/>
  <p:notesSz cx="5943600" cy="82296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E7BE7-7856-4A93-AA3A-684F81B28CF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646C94-3C2E-4C1E-9F7C-2F2E634F9D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FEA0B0-BB11-44A5-B002-C62D052FB81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0284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9536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068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0284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9536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D6AFD4-21E1-4253-A69E-33DDCF335ED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1D632E-404F-4F01-8CE3-F6E596EB1A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E089F7-7CF2-45BB-AD70-B724B302B1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C1E4F1-81B2-48C9-99C9-B598C7C27D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771961-20AC-44F5-8BF6-52BB92ED57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0680" y="347400"/>
            <a:ext cx="5596200" cy="671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98983A-6F61-4960-AC1B-C73A90E35C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A2C597-523D-4FF0-AE43-16BC773903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472078-0114-41A6-B2C6-F934C59EC1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FF621C-7276-4E25-A801-D3F993BC44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068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23640" y="8051400"/>
            <a:ext cx="197028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45572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22AB5A-87F5-4011-8B6C-33171F5E7C7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14200" y="685800"/>
          <a:ext cx="5761080" cy="6708600"/>
        </p:xfrm>
        <a:graphic>
          <a:graphicData uri="http://schemas.openxmlformats.org/drawingml/2006/table">
            <a:tbl>
              <a:tblPr/>
              <a:tblGrid>
                <a:gridCol w="1436760"/>
                <a:gridCol w="1060560"/>
                <a:gridCol w="1182600"/>
                <a:gridCol w="1143000"/>
                <a:gridCol w="938160"/>
              </a:tblGrid>
              <a:tr h="3492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μM Menadione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hysiological condi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7° C No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9° C With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9° C No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984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ANOVA  comparison of all  SCADD genotypes and control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&lt;0.0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&lt;0.0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&lt;0.0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&lt;0.0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38T/1138T (n=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.5 ± 0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.5 ± 0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.8 ± 0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.5 ± 0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96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19T/319T (n=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.0 ± 46.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.0 ± 39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.8 ± 6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.0 ± 4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r" pos="12906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38T/1138T (n=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.5 ± 0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.5 ± 0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.8 ± 0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.5 ± 0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564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319T (n=3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0.7 ± 8.9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	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2.7 ± 6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.2 ± 1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9.0 ± 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96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38T/1138T (n=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.5 ± 0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.5 ± 0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.8 ± 0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.5 ± 0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625A (n=1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7.7±12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1.1±7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1.9 ± 5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.7±3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19T/319T (n=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.0 ± 46.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.0 ± 39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.8 ± 6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.0 ± 4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319T (n=3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0.7 ± 8.9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	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2.7 ± 6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.2 ± 1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9.0 ± 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19T/319T (n=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.0 ± 46.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.0 ± 39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.8 ± 6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.0 ± 4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625A (n=1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7.7±12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1.1±7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1.9 ± 5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.7±3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319T (n=3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0.7 ± 8.9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	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2.7 ± 6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.2 ± 1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9.0 ± 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96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625A (n=1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7.7±12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1.1±7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1.9 ± 5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.7±3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38T/1138T (n=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.5 ± 0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.5 ± 0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.8 ± 0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.5 ± 0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A controls (n=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6.3 ± 24.9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6.5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14.8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5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23.0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4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22.6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19T/319T (n=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.0 ± 46.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.0 ± 39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.8 ± 6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.0 ± 4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A controls (n=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6.3 ± 24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6.5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14.8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5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23.0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4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22.6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368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319T (n=3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0.7 ± 8.9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	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2.7 ± 6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.2 ± 1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9.0 ± 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A controls (n=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6.3 ± 24.9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6.5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14.8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5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23.0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4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22.6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625A (n=1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7.7±12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1.1±7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1.9 ± 5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.7±3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A controls (n=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6.3 ± 24.9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6.5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14.8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5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23.0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4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22.6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625A (n=1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7.7±12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1.1±7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1.9 ± 5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.7±3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4600"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        (n=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48.4 ± 9.3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3.4 ± 3.4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5.6 ± 1.1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3.8 ± 2.2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1"/>
          <p:cNvSpPr/>
          <p:nvPr/>
        </p:nvSpPr>
        <p:spPr>
          <a:xfrm>
            <a:off x="-471600" y="227880"/>
            <a:ext cx="3108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r" pos="1292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Table S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"/>
          <p:cNvSpPr/>
          <p:nvPr/>
        </p:nvSpPr>
        <p:spPr>
          <a:xfrm>
            <a:off x="0" y="7473960"/>
            <a:ext cx="621828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90000" tIns="46800" bIns="46800" anchor="b">
            <a:spAutoFit/>
          </a:bodyPr>
          <a:p>
            <a:pPr>
              <a:tabLst>
                <a:tab algn="l" pos="0"/>
                <a:tab algn="r" pos="1292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Summary of menadione toxicity in the 4 SCADD patient genotypes. (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i)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One-way ANOVA and Bonferroni’s Multiple Comparisons (^ p&lt;0.05 *p&lt;0.01 ** p&lt;0.001) after logarithmic transformation, showing no significant difference in menadione toxicity between the 4 SCADD genotypes under each experimental condition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1T22:39:26Z</dcterms:created>
  <dc:creator>keith cunningham</dc:creator>
  <dc:description/>
  <dc:language>en-US</dc:language>
  <cp:lastModifiedBy>Ingrid Tein</cp:lastModifiedBy>
  <cp:lastPrinted>2011-01-27T01:12:00Z</cp:lastPrinted>
  <dcterms:modified xsi:type="dcterms:W3CDTF">2011-02-25T22:50:38Z</dcterms:modified>
  <cp:revision>33</cp:revision>
  <dc:subject/>
  <dc:title>Slide 1</dc:title>
</cp:coreProperties>
</file>